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7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4" autoAdjust="0"/>
    <p:restoredTop sz="94660"/>
  </p:normalViewPr>
  <p:slideViewPr>
    <p:cSldViewPr snapToGrid="0">
      <p:cViewPr varScale="1">
        <p:scale>
          <a:sx n="87" d="100"/>
          <a:sy n="87" d="100"/>
        </p:scale>
        <p:origin x="530" y="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799709-C393-43DF-80AE-0A11E40EF0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FEF39F-0C4D-4880-9294-A000EBCE7F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60C3BC-398B-4214-85E1-D9E64D683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82966-A828-47F7-9CF8-7534F5BC0A91}" type="datetimeFigureOut">
              <a:rPr lang="en-GB" smtClean="0"/>
              <a:t>24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F28B78-601C-4998-93CB-BAC7A2A649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4782F8-2EBD-4398-850E-E27A7F1B5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B8CCB-338A-4B54-82FD-5D040BF9E4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6520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692BD-0AEF-4640-92A8-5D00F32437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622F8B-8B9B-454F-9AD3-5020A38D97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FC99B8-2B48-46D4-8CBE-6A0BAC1310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82966-A828-47F7-9CF8-7534F5BC0A91}" type="datetimeFigureOut">
              <a:rPr lang="en-GB" smtClean="0"/>
              <a:t>24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5723E2-99CD-46F4-8BF7-9DF6C49356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6D0FB7-4772-4B4E-B03E-8F10E7DE21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B8CCB-338A-4B54-82FD-5D040BF9E4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82884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D2C8AEA-BAF2-4AFA-BECB-E9BCB97198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BA81F2-D0CF-4A96-8787-D4F9E0A6C5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1C0A88-18E6-4FF9-9172-BC86051E3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82966-A828-47F7-9CF8-7534F5BC0A91}" type="datetimeFigureOut">
              <a:rPr lang="en-GB" smtClean="0"/>
              <a:t>24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9B0593-5C60-4111-920E-F27FB2FB8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63F41E-818F-447A-B782-B4583E54A7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B8CCB-338A-4B54-82FD-5D040BF9E4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9265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4DECBF-D970-4B94-9C5A-6662FE9FE7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0609A6-B163-4A1E-8E08-E58C84CA67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BD7D40-E6BA-40E9-A9FE-AC3FEF984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82966-A828-47F7-9CF8-7534F5BC0A91}" type="datetimeFigureOut">
              <a:rPr lang="en-GB" smtClean="0"/>
              <a:t>24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8A2467-9468-41CE-8349-9401A37F3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FC56E8-4623-4574-AB4D-1B688C6B4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B8CCB-338A-4B54-82FD-5D040BF9E4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2348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E9DDFB-2DC6-4E17-9551-B87FD8BEBD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B5B9FC-9C3E-4952-A68D-9AED96A618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A3D81B-E95F-4B7B-9C39-633E55C26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82966-A828-47F7-9CF8-7534F5BC0A91}" type="datetimeFigureOut">
              <a:rPr lang="en-GB" smtClean="0"/>
              <a:t>24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D5B7A9-9C70-4B9F-B2E7-2BC723758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27717A-8F5F-45F6-B279-B3542082DB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B8CCB-338A-4B54-82FD-5D040BF9E4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7723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0A1CDE-7F66-4F57-8BD0-81AC9D06DE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EFF7B1-5FD9-4238-98AD-4CC3DA462D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9D4D91-403D-47E4-809E-2F56B4AE89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D6503C-A226-49B3-B68A-1EA8665F0C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82966-A828-47F7-9CF8-7534F5BC0A91}" type="datetimeFigureOut">
              <a:rPr lang="en-GB" smtClean="0"/>
              <a:t>24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5BCA15-455C-4D04-8312-8A0438836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C29F2A-7AEF-4999-8B30-F54751BFF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B8CCB-338A-4B54-82FD-5D040BF9E4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27304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D64917-91C6-4D59-A0C0-46BDDD6A1A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111B75-C3E0-4B36-A691-9496418982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8648AC-127A-4D1B-BE61-B72D43CBA0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816C9F6-D5D4-419E-91B2-ECFD9EC317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A5C13DD-AD63-4851-B610-52664B5D6F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3E4E4B8-D72F-4823-877F-81CA3B6CE4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82966-A828-47F7-9CF8-7534F5BC0A91}" type="datetimeFigureOut">
              <a:rPr lang="en-GB" smtClean="0"/>
              <a:t>24/07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54F188E-2877-4C5C-8986-195261165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98780A8-7609-4EE4-B4C0-90473D502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B8CCB-338A-4B54-82FD-5D040BF9E4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6508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DDC5E0-4B79-4850-B4F0-AC3635064A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C07ED4-C08E-4BD3-A4B7-4EE5043EC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82966-A828-47F7-9CF8-7534F5BC0A91}" type="datetimeFigureOut">
              <a:rPr lang="en-GB" smtClean="0"/>
              <a:t>24/07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57F5290-34CD-405B-9D13-5C986954F6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D27C696-EB60-479C-AF9B-98F29053F7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B8CCB-338A-4B54-82FD-5D040BF9E4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4074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08DFBB-773A-4322-BAB5-7C5C1CB45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82966-A828-47F7-9CF8-7534F5BC0A91}" type="datetimeFigureOut">
              <a:rPr lang="en-GB" smtClean="0"/>
              <a:t>24/07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D40813-4C13-4B53-B120-A6540DCD8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0EA381B-81E3-4C6B-8B73-D8E7B4F92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B8CCB-338A-4B54-82FD-5D040BF9E4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6888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28A960-918F-42B4-8B97-30AFDDAC03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1DFED1-699B-444D-8D4F-863041D5FD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8CA630-6724-4C39-859A-56D7888675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53F429-8830-4E74-BEE5-FEAC49B5CC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82966-A828-47F7-9CF8-7534F5BC0A91}" type="datetimeFigureOut">
              <a:rPr lang="en-GB" smtClean="0"/>
              <a:t>24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E603EF-349C-42F3-933F-820E1E9C14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21D68B-395D-4CAC-ACDC-A59E3DA87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B8CCB-338A-4B54-82FD-5D040BF9E4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5346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B6C9D7-BD50-433A-B0B1-20F85E8BAE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A45B349-DFF8-4DDA-A531-A755C6683FA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89AFD0-6F4A-4060-91DD-4553295E55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4B6AF6-45F3-4A92-90B7-5F1E9B47EF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82966-A828-47F7-9CF8-7534F5BC0A91}" type="datetimeFigureOut">
              <a:rPr lang="en-GB" smtClean="0"/>
              <a:t>24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8DE108-C163-4E46-BCFD-8F3BD2E997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77A185-82A0-46EE-9569-80AF8B24F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AB8CCB-338A-4B54-82FD-5D040BF9E4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2134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A70A3E7-6A02-4C2F-B982-1C687048E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CF76FA-98CC-4EA2-89E6-4E21B0C0B4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C504A7-F847-444F-B362-214C9C8057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182966-A828-47F7-9CF8-7534F5BC0A91}" type="datetimeFigureOut">
              <a:rPr lang="en-GB" smtClean="0"/>
              <a:t>24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07A024-FEAD-4FA6-ADFB-4CEAFEC90D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B83B5A-A487-4355-A141-F6B9D5F057F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AB8CCB-338A-4B54-82FD-5D040BF9E4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3877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sv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sv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EEC1F8-3560-4C8E-9D52-9818EDB5C82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Figure 6E</a:t>
            </a:r>
            <a:endParaRPr lang="en-GB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D6BB042-C4BA-4CC6-9DBE-19CBB1254B14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74925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10400" y="1"/>
            <a:ext cx="3657600" cy="270125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98157" y="3508490"/>
            <a:ext cx="3657600" cy="291878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55757" y="3508490"/>
            <a:ext cx="3657600" cy="291704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057693" y="6488668"/>
            <a:ext cx="908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>
                <a:latin typeface="Arial"/>
                <a:cs typeface="Arial"/>
              </a:rPr>
              <a:t>pYGIV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330081" y="6488668"/>
            <a:ext cx="908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>
                <a:latin typeface="Arial"/>
                <a:cs typeface="Arial"/>
              </a:rPr>
              <a:t>pY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9" name="TextBox 8"/>
          <p:cNvSpPr txBox="1"/>
          <p:nvPr/>
        </p:nvSpPr>
        <p:spPr>
          <a:xfrm rot="3028262">
            <a:off x="2472475" y="2941739"/>
            <a:ext cx="8466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/>
                <a:cs typeface="Arial"/>
              </a:rPr>
              <a:t>TAT-GIV-WT alone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063922" y="3075489"/>
            <a:ext cx="1556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/>
                <a:cs typeface="Arial"/>
              </a:rPr>
              <a:t>TAT-GIV-WT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436684" y="3075489"/>
            <a:ext cx="1556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/>
                <a:cs typeface="Arial"/>
              </a:rPr>
              <a:t>TAT-GIV-F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232418" y="3276287"/>
            <a:ext cx="423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N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631266" y="3276287"/>
            <a:ext cx="423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H89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060846" y="3276287"/>
            <a:ext cx="423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Cap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575142" y="3301191"/>
            <a:ext cx="423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NC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973990" y="3301191"/>
            <a:ext cx="423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H89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403570" y="3301191"/>
            <a:ext cx="423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Cap</a:t>
            </a:r>
          </a:p>
        </p:txBody>
      </p:sp>
      <p:sp>
        <p:nvSpPr>
          <p:cNvPr id="18" name="TextBox 17"/>
          <p:cNvSpPr txBox="1"/>
          <p:nvPr/>
        </p:nvSpPr>
        <p:spPr>
          <a:xfrm rot="3028262">
            <a:off x="6092995" y="2941848"/>
            <a:ext cx="8466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/>
                <a:cs typeface="Arial"/>
              </a:rPr>
              <a:t>TAT-GIV-WT alone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696893" y="3125406"/>
            <a:ext cx="1556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/>
                <a:cs typeface="Arial"/>
              </a:rPr>
              <a:t>TAT-GIV-WT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8069655" y="3125406"/>
            <a:ext cx="15564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/>
                <a:cs typeface="Arial"/>
              </a:rPr>
              <a:t>TAT-GIV-FA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865389" y="3313752"/>
            <a:ext cx="423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NC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264237" y="3313752"/>
            <a:ext cx="423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H89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693817" y="3313752"/>
            <a:ext cx="423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Cap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8208113" y="3313752"/>
            <a:ext cx="423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NC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8606961" y="3313752"/>
            <a:ext cx="423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H89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036541" y="3313752"/>
            <a:ext cx="4233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Cap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885092" y="236590"/>
            <a:ext cx="140159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Mouse samples</a:t>
            </a:r>
          </a:p>
          <a:p>
            <a:r>
              <a:rPr lang="en-US" dirty="0">
                <a:latin typeface="Arial"/>
                <a:cs typeface="Arial"/>
              </a:rPr>
              <a:t>5/18/16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855668" y="3666716"/>
            <a:ext cx="46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25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855668" y="3906280"/>
            <a:ext cx="46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150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855668" y="4208412"/>
            <a:ext cx="46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10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917923" y="4421662"/>
            <a:ext cx="46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75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893021" y="4872913"/>
            <a:ext cx="46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5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898877" y="5283986"/>
            <a:ext cx="46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37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885351" y="5959374"/>
            <a:ext cx="46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25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6659739" y="175276"/>
            <a:ext cx="46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250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6659739" y="340128"/>
            <a:ext cx="46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150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6659739" y="617356"/>
            <a:ext cx="46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100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6721994" y="830606"/>
            <a:ext cx="46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75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6697092" y="1281857"/>
            <a:ext cx="46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50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6702948" y="1655574"/>
            <a:ext cx="46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37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6689422" y="2243798"/>
            <a:ext cx="4611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25</a:t>
            </a:r>
          </a:p>
        </p:txBody>
      </p:sp>
    </p:spTree>
    <p:extLst>
      <p:ext uri="{BB962C8B-B14F-4D97-AF65-F5344CB8AC3E}">
        <p14:creationId xmlns:p14="http://schemas.microsoft.com/office/powerpoint/2010/main" val="16751473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4FAEE4BD-6E58-440B-8BEC-2DB4B59AE27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019169" y="643466"/>
            <a:ext cx="6153662" cy="55710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17935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754550CF-79DE-46A2-B9CF-37F60D10E48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053904" y="643466"/>
            <a:ext cx="6084191" cy="55710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8887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1</Words>
  <Application>Microsoft Office PowerPoint</Application>
  <PresentationFormat>Widescreen</PresentationFormat>
  <Paragraphs>3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Figure 6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6E</dc:title>
  <dc:creator>Pradipta Ghosh</dc:creator>
  <cp:lastModifiedBy>Pradipta Ghosh</cp:lastModifiedBy>
  <cp:revision>2</cp:revision>
  <dcterms:created xsi:type="dcterms:W3CDTF">2021-04-27T19:36:15Z</dcterms:created>
  <dcterms:modified xsi:type="dcterms:W3CDTF">2021-07-25T04:39:35Z</dcterms:modified>
</cp:coreProperties>
</file>